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nrique María Mateu de Antonio" userId="678ddb83-0020-4a06-85d2-928a222534ef" providerId="ADAL" clId="{00CA1554-EEBA-44F6-99F7-9783B6093B2E}"/>
    <pc:docChg chg="modSld">
      <pc:chgData name="Enrique María Mateu de Antonio" userId="678ddb83-0020-4a06-85d2-928a222534ef" providerId="ADAL" clId="{00CA1554-EEBA-44F6-99F7-9783B6093B2E}" dt="2025-04-07T13:44:41.575" v="9" actId="113"/>
      <pc:docMkLst>
        <pc:docMk/>
      </pc:docMkLst>
      <pc:sldChg chg="addSp modSp mod">
        <pc:chgData name="Enrique María Mateu de Antonio" userId="678ddb83-0020-4a06-85d2-928a222534ef" providerId="ADAL" clId="{00CA1554-EEBA-44F6-99F7-9783B6093B2E}" dt="2025-04-07T13:44:41.575" v="9" actId="113"/>
        <pc:sldMkLst>
          <pc:docMk/>
          <pc:sldMk cId="1903058752" sldId="256"/>
        </pc:sldMkLst>
        <pc:spChg chg="add mod">
          <ac:chgData name="Enrique María Mateu de Antonio" userId="678ddb83-0020-4a06-85d2-928a222534ef" providerId="ADAL" clId="{00CA1554-EEBA-44F6-99F7-9783B6093B2E}" dt="2025-04-07T13:44:41.575" v="9" actId="113"/>
          <ac:spMkLst>
            <pc:docMk/>
            <pc:sldMk cId="1903058752" sldId="256"/>
            <ac:spMk id="3" creationId="{FCCDC786-4535-3F14-E27E-122156D53C6F}"/>
          </ac:spMkLst>
        </pc:spChg>
        <pc:picChg chg="mod">
          <ac:chgData name="Enrique María Mateu de Antonio" userId="678ddb83-0020-4a06-85d2-928a222534ef" providerId="ADAL" clId="{00CA1554-EEBA-44F6-99F7-9783B6093B2E}" dt="2025-04-07T13:44:24.190" v="1" actId="1076"/>
          <ac:picMkLst>
            <pc:docMk/>
            <pc:sldMk cId="1903058752" sldId="256"/>
            <ac:picMk id="4" creationId="{292E3B27-234B-ADBE-A479-6D1575ADCCF3}"/>
          </ac:picMkLst>
        </pc:picChg>
      </pc:sldChg>
    </pc:docChg>
  </pc:docChgLst>
  <pc:docChgLst>
    <pc:chgData name="Enrique María Mateu de Antonio" userId="678ddb83-0020-4a06-85d2-928a222534ef" providerId="ADAL" clId="{3E38E54B-39BF-4DC1-91C6-16F803C868B0}"/>
    <pc:docChg chg="modSld">
      <pc:chgData name="Enrique María Mateu de Antonio" userId="678ddb83-0020-4a06-85d2-928a222534ef" providerId="ADAL" clId="{3E38E54B-39BF-4DC1-91C6-16F803C868B0}" dt="2025-04-22T12:46:54.740" v="2" actId="255"/>
      <pc:docMkLst>
        <pc:docMk/>
      </pc:docMkLst>
      <pc:sldChg chg="modSp mod">
        <pc:chgData name="Enrique María Mateu de Antonio" userId="678ddb83-0020-4a06-85d2-928a222534ef" providerId="ADAL" clId="{3E38E54B-39BF-4DC1-91C6-16F803C868B0}" dt="2025-04-22T12:46:54.740" v="2" actId="255"/>
        <pc:sldMkLst>
          <pc:docMk/>
          <pc:sldMk cId="1903058752" sldId="256"/>
        </pc:sldMkLst>
        <pc:spChg chg="mod">
          <ac:chgData name="Enrique María Mateu de Antonio" userId="678ddb83-0020-4a06-85d2-928a222534ef" providerId="ADAL" clId="{3E38E54B-39BF-4DC1-91C6-16F803C868B0}" dt="2025-04-22T12:46:54.740" v="2" actId="255"/>
          <ac:spMkLst>
            <pc:docMk/>
            <pc:sldMk cId="1903058752" sldId="256"/>
            <ac:spMk id="3" creationId="{FCCDC786-4535-3F14-E27E-122156D53C6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1380768D-F87F-579E-DD81-5EA471AB3F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Subtítol 2">
            <a:extLst>
              <a:ext uri="{FF2B5EF4-FFF2-40B4-BE49-F238E27FC236}">
                <a16:creationId xmlns:a16="http://schemas.microsoft.com/office/drawing/2014/main" id="{A5625079-A8FF-8F13-3C60-788DFC9C23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E38F038F-C1D0-E7C7-DE87-095284E38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BD663DD0-3FA7-4BF0-0267-1BA0930CD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6C1DCD08-E2E6-36AC-ED75-1ED58FC72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3090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5E5DE160-ED6D-FC8B-9DB2-1F46ED4D5F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AA580FC1-DB3C-F2CF-FBA9-146B01B159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FEEE4F4B-FF9C-D31F-6EC0-D52486216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14053E18-72FD-D80A-F1AF-515C4C75A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EB56BFC8-CCD8-4992-0069-1E62F954C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8068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>
            <a:extLst>
              <a:ext uri="{FF2B5EF4-FFF2-40B4-BE49-F238E27FC236}">
                <a16:creationId xmlns:a16="http://schemas.microsoft.com/office/drawing/2014/main" id="{D0A746D4-F838-707D-4EAA-198FBE4992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8C6002DE-9680-C8BD-0C57-138CFA0586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C18BB867-2517-FD45-D5E6-E54A90271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E1A72240-8479-D26E-9E22-C13DF8706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A5D5872D-F001-6774-8803-652DB56FF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5155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7B21B37C-1AF7-960C-2192-D41317DF3E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F0410284-9F99-1AB9-DDC8-5FEADA1693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5254C08D-5E4A-6F62-A4D7-91BD88F84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F29F0D5A-1BDB-28BE-4CA9-2C98ACBF4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70CB9B9C-8D27-CF87-8647-FD84C56D4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7108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5B9C9827-B7F7-4353-9F8F-6A168D5DE8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1FE0C16D-F4C7-91E0-7BE1-3026EB3011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597CC401-54D6-614A-CBF4-799AC04D7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AF3FC5A3-1804-D96F-93CC-13B8EBC462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183F7EB0-A969-92ED-B452-43E67DEC1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1208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0CFA92FE-C9DE-4460-D2C3-05422AE9B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AD10BDAD-CEF8-B8C8-62A7-625A0EA2C7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414FEEE8-BD95-90DF-791E-63049A74C4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CC97950F-B3DD-9AB6-2CDD-1451BFD27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18681077-CC0E-D1A4-944B-B36D0916D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6636D2BF-8DC1-19CB-4998-68C89C378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1563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67F45B3B-6B44-A513-07CB-3A1B97B76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2FFB1DCF-674F-E384-B7A8-B21B5CE52C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8678AD94-5BFD-320F-40D2-6B4C44DE51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text 4">
            <a:extLst>
              <a:ext uri="{FF2B5EF4-FFF2-40B4-BE49-F238E27FC236}">
                <a16:creationId xmlns:a16="http://schemas.microsoft.com/office/drawing/2014/main" id="{B595916E-2CD9-2CD4-BE5F-A77381A233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6" name="Contenidor de contingut 5">
            <a:extLst>
              <a:ext uri="{FF2B5EF4-FFF2-40B4-BE49-F238E27FC236}">
                <a16:creationId xmlns:a16="http://schemas.microsoft.com/office/drawing/2014/main" id="{CF355BA5-A335-A207-0CF7-0CAC9CDE4E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7" name="Contenidor de data 6">
            <a:extLst>
              <a:ext uri="{FF2B5EF4-FFF2-40B4-BE49-F238E27FC236}">
                <a16:creationId xmlns:a16="http://schemas.microsoft.com/office/drawing/2014/main" id="{EDA8FAA9-A0DC-8598-1DFB-F8C8B1F35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8" name="Contenidor de peu de pàgina 7">
            <a:extLst>
              <a:ext uri="{FF2B5EF4-FFF2-40B4-BE49-F238E27FC236}">
                <a16:creationId xmlns:a16="http://schemas.microsoft.com/office/drawing/2014/main" id="{BDFAD7E9-C558-D711-509A-D2E665C67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>
            <a:extLst>
              <a:ext uri="{FF2B5EF4-FFF2-40B4-BE49-F238E27FC236}">
                <a16:creationId xmlns:a16="http://schemas.microsoft.com/office/drawing/2014/main" id="{7F09AC83-1FCD-5FA1-BABD-D97C51293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4693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E3929090-DCD4-6AD5-7BA4-DF48A0D671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data 2">
            <a:extLst>
              <a:ext uri="{FF2B5EF4-FFF2-40B4-BE49-F238E27FC236}">
                <a16:creationId xmlns:a16="http://schemas.microsoft.com/office/drawing/2014/main" id="{70C3916A-4EA5-371C-9BE4-B15E01ED0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4" name="Contenidor de peu de pàgina 3">
            <a:extLst>
              <a:ext uri="{FF2B5EF4-FFF2-40B4-BE49-F238E27FC236}">
                <a16:creationId xmlns:a16="http://schemas.microsoft.com/office/drawing/2014/main" id="{68DEDA60-8635-616B-4EAD-B3784CF02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>
            <a:extLst>
              <a:ext uri="{FF2B5EF4-FFF2-40B4-BE49-F238E27FC236}">
                <a16:creationId xmlns:a16="http://schemas.microsoft.com/office/drawing/2014/main" id="{55FFF71A-59F0-0AD9-A2E1-A5FD95D92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131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>
            <a:extLst>
              <a:ext uri="{FF2B5EF4-FFF2-40B4-BE49-F238E27FC236}">
                <a16:creationId xmlns:a16="http://schemas.microsoft.com/office/drawing/2014/main" id="{C3A9CA29-AC2B-573B-60F7-7B6DAF730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3" name="Contenidor de peu de pàgina 2">
            <a:extLst>
              <a:ext uri="{FF2B5EF4-FFF2-40B4-BE49-F238E27FC236}">
                <a16:creationId xmlns:a16="http://schemas.microsoft.com/office/drawing/2014/main" id="{1AAC2C78-7C32-6F81-BE03-B1CB9FCDF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>
            <a:extLst>
              <a:ext uri="{FF2B5EF4-FFF2-40B4-BE49-F238E27FC236}">
                <a16:creationId xmlns:a16="http://schemas.microsoft.com/office/drawing/2014/main" id="{48095C9D-D0E0-C914-0CA2-ACDCB3AD20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9438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B57C04AD-45CC-58D5-24E9-5C7EFE34E3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5D95C402-7C59-C133-EE9F-3D0D68CF9C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F62B994B-A4E5-5781-2D0B-FEAF2ED104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24C85A92-771B-CE9F-57E1-50F923A06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4D8A7656-1C77-7C6A-B78A-5CE13B10D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8F928B27-2721-5B6A-3CC6-B086CB8F3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8696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BD3F888D-D921-17DC-569B-03D8E04B29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'imatge 2">
            <a:extLst>
              <a:ext uri="{FF2B5EF4-FFF2-40B4-BE49-F238E27FC236}">
                <a16:creationId xmlns:a16="http://schemas.microsoft.com/office/drawing/2014/main" id="{6570E4CE-F49A-8793-F2DA-EAFE665C63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3A85AD7C-687C-A59D-FC12-8C1CC7EBED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0E243136-3A0C-9437-06B9-FE466450CD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8EDF9B03-9906-7F1E-21F7-9524C6E43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18F43FEF-FA30-42DA-822F-8D4DFA7A7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9745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>
            <a:extLst>
              <a:ext uri="{FF2B5EF4-FFF2-40B4-BE49-F238E27FC236}">
                <a16:creationId xmlns:a16="http://schemas.microsoft.com/office/drawing/2014/main" id="{FD6A36CB-7032-2A79-4A20-9C344AB8DE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0E159369-7054-17CA-5979-AE2A94B742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385247CD-DEE7-6FF9-8A27-9D882943E4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DD3459-1850-4C11-B606-BF89A92D7364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94425958-B619-348D-FA60-3F6FFAB34B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640BF504-6828-6FBB-5597-2FA6D4E757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398A1C-D3F7-473E-9ACC-69622FAC84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2337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tge 3">
            <a:extLst>
              <a:ext uri="{FF2B5EF4-FFF2-40B4-BE49-F238E27FC236}">
                <a16:creationId xmlns:a16="http://schemas.microsoft.com/office/drawing/2014/main" id="{292E3B27-234B-ADBE-A479-6D1575ADCC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9393" y="899772"/>
            <a:ext cx="6653213" cy="5958228"/>
          </a:xfrm>
          <a:prstGeom prst="rect">
            <a:avLst/>
          </a:prstGeom>
        </p:spPr>
      </p:pic>
      <p:sp>
        <p:nvSpPr>
          <p:cNvPr id="3" name="QuadreDeText 2">
            <a:extLst>
              <a:ext uri="{FF2B5EF4-FFF2-40B4-BE49-F238E27FC236}">
                <a16:creationId xmlns:a16="http://schemas.microsoft.com/office/drawing/2014/main" id="{FCCDC786-4535-3F14-E27E-122156D53C6F}"/>
              </a:ext>
            </a:extLst>
          </p:cNvPr>
          <p:cNvSpPr txBox="1"/>
          <p:nvPr/>
        </p:nvSpPr>
        <p:spPr>
          <a:xfrm>
            <a:off x="428625" y="218212"/>
            <a:ext cx="1148715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4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ekl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in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PC =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t-challeng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V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non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non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V/Ch = no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or =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rcil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R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L = Innovac 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 = p&lt;0.05; ** = p&lt;0.01; *** = p&lt;0.001, **** =p&lt;0.0001.</a:t>
            </a:r>
          </a:p>
        </p:txBody>
      </p:sp>
    </p:spTree>
    <p:extLst>
      <p:ext uri="{BB962C8B-B14F-4D97-AF65-F5344CB8AC3E}">
        <p14:creationId xmlns:p14="http://schemas.microsoft.com/office/powerpoint/2010/main" val="19030587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icin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2</Words>
  <Application>Microsoft Office PowerPoint</Application>
  <PresentationFormat>Pantalla panorà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e l'Office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nrique María Mateu de Antonio</dc:creator>
  <cp:lastModifiedBy>Enrique María Mateu de Antonio</cp:lastModifiedBy>
  <cp:revision>1</cp:revision>
  <dcterms:created xsi:type="dcterms:W3CDTF">2025-02-06T14:31:32Z</dcterms:created>
  <dcterms:modified xsi:type="dcterms:W3CDTF">2025-04-22T12:46:55Z</dcterms:modified>
</cp:coreProperties>
</file>